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C21DE-F9EB-47F0-9BE6-A91CD54BE7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AF481-8A34-4145-B262-123C6571CB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C538BB-5B44-4F1F-8DB8-9476F3DF11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5468C-38A4-463B-A336-54EEBAA15C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7A96F7-8DCE-4EEA-87E3-2BABF2F3149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C3F299-DF7E-42CD-BF0C-684FE8006F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5C142E-8599-45FD-BF9A-B872A61716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6D905-2927-4548-B5D0-DE1615B73D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2B043-59F7-408F-9ED9-FCAB40F85D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5B9DB-1073-492B-963F-884E39DE8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A7CDB4-0AC9-4A38-9931-17967EC7D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6018C-3E5B-474B-A34A-049ADDE8B8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E86F0A-5A45-4F81-B291-91CAA3FB0D3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10520" y="842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79680" y="-9360"/>
            <a:ext cx="3178080" cy="2218320"/>
            <a:chOff x="1579680" y="-9360"/>
            <a:chExt cx="3178080" cy="2218320"/>
          </a:xfrm>
        </p:grpSpPr>
        <p:grpSp>
          <p:nvGrpSpPr>
            <p:cNvPr id="43" name=""/>
            <p:cNvGrpSpPr/>
            <p:nvPr/>
          </p:nvGrpSpPr>
          <p:grpSpPr>
            <a:xfrm>
              <a:off x="1579680" y="-9360"/>
              <a:ext cx="3178080" cy="2218320"/>
              <a:chOff x="1579680" y="-9360"/>
              <a:chExt cx="3178080" cy="2218320"/>
            </a:xfrm>
          </p:grpSpPr>
          <p:sp>
            <p:nvSpPr>
              <p:cNvPr id="44" name=""/>
              <p:cNvSpPr/>
              <p:nvPr/>
            </p:nvSpPr>
            <p:spPr>
              <a:xfrm>
                <a:off x="2067120" y="68040"/>
                <a:ext cx="2554920" cy="17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"/>
              <p:cNvGrpSpPr/>
              <p:nvPr/>
            </p:nvGrpSpPr>
            <p:grpSpPr>
              <a:xfrm>
                <a:off x="2681280" y="79920"/>
                <a:ext cx="998640" cy="226800"/>
                <a:chOff x="2681280" y="79920"/>
                <a:chExt cx="998640" cy="226800"/>
              </a:xfrm>
            </p:grpSpPr>
            <p:sp>
              <p:nvSpPr>
                <p:cNvPr id="46" name=""/>
                <p:cNvSpPr/>
                <p:nvPr/>
              </p:nvSpPr>
              <p:spPr>
                <a:xfrm>
                  <a:off x="2681280" y="93240"/>
                  <a:ext cx="4748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NS5B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3114360" y="79920"/>
                  <a:ext cx="1105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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3223440" y="91440"/>
                  <a:ext cx="45648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21 1b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9" name=""/>
              <p:cNvSpPr/>
              <p:nvPr/>
            </p:nvSpPr>
            <p:spPr>
              <a:xfrm>
                <a:off x="2067120" y="1785960"/>
                <a:ext cx="25563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067120" y="178596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999440" y="185184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2918160" y="178596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777760" y="185184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770640" y="178596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3593160" y="185184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623480" y="178596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446000" y="185184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2067120" y="68040"/>
                <a:ext cx="0" cy="171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H="1">
                <a:off x="2017440" y="178596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865160" y="17085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H="1">
                <a:off x="2017440" y="144180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865160" y="136548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>
                <a:off x="2017440" y="109872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865160" y="10209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H="1">
                <a:off x="2017440" y="7556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865160" y="67788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H="1">
                <a:off x="2017440" y="41112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865160" y="3351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H="1">
                <a:off x="2017440" y="680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865160" y="-93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057760" y="17773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2074320" y="1777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2092320" y="17773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2108520" y="1777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126520" y="1775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143080" y="1772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161080" y="1769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177280" y="17654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193840" y="1761120"/>
                <a:ext cx="1728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211480" y="17550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228040" y="17456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245680" y="173556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261880" y="17233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281680" y="17103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297880" y="1693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314440" y="16776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332440" y="16578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348640" y="163728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366640" y="16146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383200" y="158904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400480" y="15638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417040" y="15382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433600" y="15102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451240" y="148068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2467800" y="14504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2487240" y="14194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2503800" y="1387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2521800" y="13564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2538000" y="13255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2554560" y="12938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2572560" y="12628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2588760" y="1230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2606400" y="11984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622960" y="116892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640600" y="11390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2657160" y="11088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2675160" y="108072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2691360" y="10522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709360" y="102564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727360" y="9986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743920" y="9748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2761560" y="9496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777760" y="9255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795760" y="9032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812320" y="8809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2828520" y="8614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2846520" y="8406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2862720" y="8211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2880720" y="8017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2897280" y="7855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2916360" y="7675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2932920" y="7527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2949480" y="737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2967120" y="7225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2983680" y="7095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001680" y="69444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3017880" y="6840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3035880" y="6706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3052440" y="6588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3068640" y="6483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086640" y="6379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102840" y="6274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120840" y="6184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138480" y="6094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156480" y="6004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173040" y="5914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189240" y="5857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207240" y="5767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223800" y="569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241800" y="5616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258000" y="5554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276000" y="54972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292200" y="5436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308760" y="5378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326760" y="5320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3344400" y="5274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362400" y="521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378600" y="516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396600" y="51408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3413160" y="5079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429360" y="5036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3447360" y="5004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3463920" y="496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3481920" y="491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3498120" y="488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3515760" y="4842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531960" y="481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549960" y="4798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567960" y="4766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584520" y="4737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602520" y="4708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3618720" y="4676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3636720" y="46476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653280" y="461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670920" y="4600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3687480" y="4572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3704040" y="45432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3721320" y="452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3737880" y="449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3755880" y="4485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773880" y="44712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3791880" y="44532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3808080" y="4438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3824640" y="4424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3842640" y="4410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3858840" y="4395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876480" y="4366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3893040" y="4348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3911040" y="4334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3927240" y="4316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3943800" y="43056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3961440" y="43056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979440" y="4291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3997440" y="4273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4014000" y="4262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4031640" y="4244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047840" y="4230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4064400" y="4230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4082400" y="4215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4098600" y="420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4116600" y="4186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4133160" y="41868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4150800" y="416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4167360" y="416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4185360" y="4154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4203360" y="41436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4219560" y="41436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237200" y="4125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4253760" y="4125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4271760" y="4111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287960" y="411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305960" y="4093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322520" y="4093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338720" y="4093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356720" y="4093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373280" y="408240"/>
                <a:ext cx="1728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4390920" y="4082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4408560" y="4068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426560" y="4068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443120" y="4068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4459320" y="4050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477320" y="4050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4493880" y="4050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4511880" y="40392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4528080" y="4039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4546080" y="4039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4562640" y="40212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4578840" y="4021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4596840" y="4021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4614480" y="4006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4623480" y="306720"/>
                <a:ext cx="0" cy="378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607280" y="306720"/>
                <a:ext cx="3276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4607280" y="685440"/>
                <a:ext cx="3276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4112280" y="327600"/>
                <a:ext cx="0" cy="45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" bIns="-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4094280" y="3276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4094280" y="37368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3089520" y="475200"/>
                <a:ext cx="0" cy="3204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3071520" y="4752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3071520" y="7956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2577960" y="1298520"/>
                <a:ext cx="0" cy="50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" bIns="3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2560320" y="129852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2560320" y="134892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2372760" y="151164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2322000" y="167868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2193840" y="177840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2130840" y="178344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2067120" y="178596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4607280" y="479880"/>
                <a:ext cx="3276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4094280" y="333360"/>
                <a:ext cx="3384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3071520" y="61848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2560320" y="130608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2356200" y="1493640"/>
                <a:ext cx="3420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2305440" y="1661040"/>
                <a:ext cx="3420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"/>
              <p:cNvSpPr/>
              <p:nvPr/>
            </p:nvSpPr>
            <p:spPr>
              <a:xfrm>
                <a:off x="2177280" y="176220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2112840" y="176544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2049120" y="176832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3034440" y="2026080"/>
                <a:ext cx="669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 rot="16200000">
                <a:off x="801360" y="802800"/>
                <a:ext cx="17244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v (pmoles/min) xnM NS5B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9" name=""/>
            <p:cNvSpPr/>
            <p:nvPr/>
          </p:nvSpPr>
          <p:spPr>
            <a:xfrm>
              <a:off x="3118680" y="1144440"/>
              <a:ext cx="1123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= 0.9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50" name=""/>
          <p:cNvGrpSpPr/>
          <p:nvPr/>
        </p:nvGrpSpPr>
        <p:grpSpPr>
          <a:xfrm>
            <a:off x="5270400" y="-25920"/>
            <a:ext cx="3154320" cy="2268360"/>
            <a:chOff x="5270400" y="-25920"/>
            <a:chExt cx="3154320" cy="2268360"/>
          </a:xfrm>
        </p:grpSpPr>
        <p:grpSp>
          <p:nvGrpSpPr>
            <p:cNvPr id="251" name=""/>
            <p:cNvGrpSpPr/>
            <p:nvPr/>
          </p:nvGrpSpPr>
          <p:grpSpPr>
            <a:xfrm>
              <a:off x="5270400" y="-25920"/>
              <a:ext cx="3154320" cy="2268360"/>
              <a:chOff x="5270400" y="-25920"/>
              <a:chExt cx="3154320" cy="2268360"/>
            </a:xfrm>
          </p:grpSpPr>
          <p:sp>
            <p:nvSpPr>
              <p:cNvPr id="252" name=""/>
              <p:cNvSpPr/>
              <p:nvPr/>
            </p:nvSpPr>
            <p:spPr>
              <a:xfrm>
                <a:off x="5734080" y="101160"/>
                <a:ext cx="2554920" cy="17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53" name=""/>
              <p:cNvGrpSpPr/>
              <p:nvPr/>
            </p:nvGrpSpPr>
            <p:grpSpPr>
              <a:xfrm>
                <a:off x="6476400" y="126720"/>
                <a:ext cx="990000" cy="226800"/>
                <a:chOff x="6476400" y="126720"/>
                <a:chExt cx="990000" cy="226800"/>
              </a:xfrm>
            </p:grpSpPr>
            <p:sp>
              <p:nvSpPr>
                <p:cNvPr id="254" name=""/>
                <p:cNvSpPr/>
                <p:nvPr/>
              </p:nvSpPr>
              <p:spPr>
                <a:xfrm>
                  <a:off x="6476400" y="140040"/>
                  <a:ext cx="4748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NS5B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"/>
                <p:cNvSpPr/>
                <p:nvPr/>
              </p:nvSpPr>
              <p:spPr>
                <a:xfrm>
                  <a:off x="6910920" y="126720"/>
                  <a:ext cx="1105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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"/>
                <p:cNvSpPr/>
                <p:nvPr/>
              </p:nvSpPr>
              <p:spPr>
                <a:xfrm>
                  <a:off x="7019280" y="140040"/>
                  <a:ext cx="4471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21 2a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57" name=""/>
              <p:cNvSpPr/>
              <p:nvPr/>
            </p:nvSpPr>
            <p:spPr>
              <a:xfrm>
                <a:off x="5734080" y="1819440"/>
                <a:ext cx="255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5734080" y="181944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5666400" y="188388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6585120" y="181944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6445080" y="188388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7437960" y="181944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7260480" y="188388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8290440" y="181944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8112960" y="188388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 flipV="1">
                <a:off x="5734080" y="101160"/>
                <a:ext cx="0" cy="171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 flipH="1">
                <a:off x="5684400" y="18194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5532120" y="174204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 flipH="1">
                <a:off x="5684400" y="138996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5532120" y="13125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 flipH="1">
                <a:off x="5684400" y="96048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5532120" y="88272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 flipH="1">
                <a:off x="5684400" y="5306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5532120" y="45324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 flipH="1">
                <a:off x="5684400" y="10116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5532120" y="2376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5724720" y="1810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5741640" y="1810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5759280" y="18093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5775480" y="18075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5793480" y="18046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5810040" y="180180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5828040" y="17971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5844240" y="17942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5860800" y="178956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5878440" y="17838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5895000" y="17766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5913000" y="17704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>
                <a:off x="5929200" y="17629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5948640" y="17553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5964840" y="174816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5981400" y="1737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5999400" y="172872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6015600" y="17197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6033600" y="170928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6050160" y="169884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6067800" y="16880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6084360" y="16779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6100560" y="1665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6118560" y="16542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6135120" y="16434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6154200" y="1631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6170760" y="16182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6188760" y="160632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6204960" y="15930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6221520" y="15811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6239520" y="156744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6255720" y="155412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6273720" y="15422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6290280" y="152712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6307560" y="151416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6324120" y="15019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6342120" y="14868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6358320" y="14752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6376320" y="14601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6394320" y="14454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6410880" y="14331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6428880" y="14184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6445080" y="1405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6462720" y="13914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6479280" y="13780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6495480" y="13662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6513480" y="13514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6529680" y="1337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6547680" y="13258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6564240" y="1311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6583680" y="12974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6600240" y="12855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6616440" y="12722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6634080" y="126036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6650640" y="12466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6668640" y="12333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6684840" y="12232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6702840" y="12096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6719400" y="11977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6735600" y="11854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6753600" y="11736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6769800" y="1162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6787800" y="11502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6805800" y="11379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6823440" y="11260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6840000" y="11174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6856200" y="11052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6874200" y="10933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6890760" y="1082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6908760" y="107244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6924960" y="1061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6942960" y="10512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6959160" y="104256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6975720" y="10306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6993720" y="10216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7011360" y="10126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7029360" y="10022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7045560" y="991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7063560" y="9831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7080120" y="9738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7096320" y="9651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7114320" y="955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7130880" y="9453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7148880" y="9381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7165080" y="9291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7183080" y="9216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7199280" y="9126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7216920" y="9050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7234920" y="8964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7251480" y="8888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7269480" y="8798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7285680" y="8722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7303680" y="8665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7320240" y="8593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7338240" y="851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7354440" y="84420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7371000" y="83664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7388280" y="8308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7404840" y="8233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7422840" y="815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7440840" y="809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7458840" y="8024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7475040" y="7963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7491600" y="7905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7509600" y="78444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7525800" y="776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7543440" y="7707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7560000" y="7650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7578000" y="7606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7594200" y="75456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7610760" y="74844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7628400" y="7426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7646400" y="7369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7664400" y="730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7680960" y="7279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7698600" y="7218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7715160" y="7174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7731720" y="7113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7749360" y="7070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7765560" y="7009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7783560" y="6966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7800120" y="692280"/>
                <a:ext cx="1728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7817760" y="6876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7834320" y="6829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7852320" y="6786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7870320" y="674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7886520" y="669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7904160" y="6649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7920720" y="6606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7938720" y="656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7954920" y="6530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7972920" y="6487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7989480" y="6444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8005680" y="6397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8023680" y="6368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8040240" y="63216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8057880" y="6278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8075520" y="624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8093520" y="6202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8110080" y="6192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8126280" y="6141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8144280" y="6116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8160840" y="6069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8178840" y="6040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8195040" y="6012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8213040" y="59688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8229600" y="5936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8245800" y="590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8263800" y="5875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8281440" y="5846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8290440" y="551880"/>
                <a:ext cx="0" cy="71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8274240" y="551880"/>
                <a:ext cx="3276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8274240" y="623520"/>
                <a:ext cx="3276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7779240" y="599400"/>
                <a:ext cx="0" cy="2163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7761240" y="5994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7761240" y="81576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6756480" y="1103760"/>
                <a:ext cx="0" cy="2127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6738840" y="110376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6738840" y="131688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6500160" y="1291320"/>
                <a:ext cx="0" cy="108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6483960" y="129132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6483960" y="14004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6245280" y="1527120"/>
                <a:ext cx="0" cy="536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6227280" y="152712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6227280" y="158112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6039720" y="1665720"/>
                <a:ext cx="0" cy="925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>
                <a:off x="6023160" y="166572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>
                <a:off x="6023160" y="175860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"/>
              <p:cNvSpPr/>
              <p:nvPr/>
            </p:nvSpPr>
            <p:spPr>
              <a:xfrm>
                <a:off x="5988960" y="180468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>
                <a:off x="5860800" y="181656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5734080" y="181944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>
                <a:off x="8274240" y="571320"/>
                <a:ext cx="3276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>
                <a:off x="7761240" y="690480"/>
                <a:ext cx="3384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>
                <a:off x="6738840" y="119160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>
                <a:off x="6483960" y="132912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6227280" y="153756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6023160" y="1694160"/>
                <a:ext cx="3420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>
                <a:off x="5972400" y="178848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>
                <a:off x="5844240" y="179892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>
                <a:off x="5716080" y="180180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>
                <a:off x="6701400" y="2059560"/>
                <a:ext cx="669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 rot="16200000">
                <a:off x="4424040" y="820080"/>
                <a:ext cx="1875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v (pmoles/min) x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9" name=""/>
            <p:cNvSpPr/>
            <p:nvPr/>
          </p:nvSpPr>
          <p:spPr>
            <a:xfrm>
              <a:off x="6884280" y="1268280"/>
              <a:ext cx="1123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= 0.9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0" name=""/>
          <p:cNvGrpSpPr/>
          <p:nvPr/>
        </p:nvGrpSpPr>
        <p:grpSpPr>
          <a:xfrm>
            <a:off x="1579680" y="2215440"/>
            <a:ext cx="3244680" cy="2268360"/>
            <a:chOff x="1579680" y="2215440"/>
            <a:chExt cx="3244680" cy="2268360"/>
          </a:xfrm>
        </p:grpSpPr>
        <p:grpSp>
          <p:nvGrpSpPr>
            <p:cNvPr id="461" name=""/>
            <p:cNvGrpSpPr/>
            <p:nvPr/>
          </p:nvGrpSpPr>
          <p:grpSpPr>
            <a:xfrm>
              <a:off x="1579680" y="2215440"/>
              <a:ext cx="3244680" cy="2268360"/>
              <a:chOff x="1579680" y="2215440"/>
              <a:chExt cx="3244680" cy="2268360"/>
            </a:xfrm>
          </p:grpSpPr>
          <p:sp>
            <p:nvSpPr>
              <p:cNvPr id="462" name=""/>
              <p:cNvSpPr/>
              <p:nvPr/>
            </p:nvSpPr>
            <p:spPr>
              <a:xfrm>
                <a:off x="2116080" y="2342520"/>
                <a:ext cx="2572200" cy="17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63" name=""/>
              <p:cNvGrpSpPr/>
              <p:nvPr/>
            </p:nvGrpSpPr>
            <p:grpSpPr>
              <a:xfrm>
                <a:off x="2917800" y="2354760"/>
                <a:ext cx="994680" cy="226440"/>
                <a:chOff x="2917800" y="2354760"/>
                <a:chExt cx="994680" cy="226440"/>
              </a:xfrm>
            </p:grpSpPr>
            <p:sp>
              <p:nvSpPr>
                <p:cNvPr id="464" name=""/>
                <p:cNvSpPr/>
                <p:nvPr/>
              </p:nvSpPr>
              <p:spPr>
                <a:xfrm>
                  <a:off x="2917800" y="2367720"/>
                  <a:ext cx="4748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NS5B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"/>
                <p:cNvSpPr/>
                <p:nvPr/>
              </p:nvSpPr>
              <p:spPr>
                <a:xfrm>
                  <a:off x="3355920" y="2354760"/>
                  <a:ext cx="1105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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"/>
                <p:cNvSpPr/>
                <p:nvPr/>
              </p:nvSpPr>
              <p:spPr>
                <a:xfrm>
                  <a:off x="3465360" y="2366280"/>
                  <a:ext cx="4471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21 3a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67" name=""/>
              <p:cNvSpPr/>
              <p:nvPr/>
            </p:nvSpPr>
            <p:spPr>
              <a:xfrm>
                <a:off x="2116080" y="4060800"/>
                <a:ext cx="257364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>
                <a:off x="2116080" y="40608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>
                <a:off x="2048760" y="412524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>
                <a:off x="2974680" y="40608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>
                <a:off x="2834280" y="412524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3831480" y="40608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3654000" y="412524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4690080" y="40608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4512600" y="412524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 flipV="1">
                <a:off x="2116080" y="2342520"/>
                <a:ext cx="0" cy="171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 flipH="1">
                <a:off x="2066400" y="406080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1805040" y="398340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 flipH="1">
                <a:off x="2066400" y="34880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1805040" y="341064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 flipH="1">
                <a:off x="2066400" y="29156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>
                <a:off x="1805040" y="283824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 flipH="1">
                <a:off x="2066400" y="234252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>
                <a:off x="1805040" y="226512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2107080" y="40521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>
                <a:off x="2123640" y="4052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2141640" y="40521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>
                <a:off x="2157840" y="4052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>
                <a:off x="2175840" y="4052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>
                <a:off x="2193480" y="40521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2210040" y="4052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2228040" y="40521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2244240" y="4050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>
                <a:off x="2262240" y="40507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>
                <a:off x="2278440" y="40489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2296440" y="40474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2313000" y="40460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>
                <a:off x="2332080" y="404316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2348640" y="40402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>
                <a:off x="2366640" y="40370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>
                <a:off x="2382840" y="40327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2400840" y="40280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2417400" y="402048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2435040" y="40147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>
                <a:off x="2451600" y="4005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>
                <a:off x="2469600" y="39981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>
                <a:off x="2485800" y="39862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>
                <a:off x="2503440" y="39744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2520000" y="39639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>
                <a:off x="2539440" y="39492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>
                <a:off x="2556000" y="3932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2574000" y="39178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2590200" y="3899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2607840" y="388188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2624400" y="386136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>
                <a:off x="2642040" y="38401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>
                <a:off x="2658600" y="38192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>
                <a:off x="2676600" y="379548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2692800" y="37717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>
                <a:off x="2710800" y="37476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2727360" y="37224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>
                <a:off x="2745360" y="369720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2763000" y="36720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>
                <a:off x="2781000" y="36446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2797200" y="36180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>
                <a:off x="2815200" y="35928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2833200" y="35658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>
                <a:off x="2849400" y="3538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>
                <a:off x="2867400" y="35136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>
                <a:off x="2883960" y="34880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2901600" y="34646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>
                <a:off x="2917800" y="3439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2935800" y="341496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2952360" y="33926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2971800" y="3368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>
                <a:off x="2988360" y="3348000"/>
                <a:ext cx="1728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3005640" y="332568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3022200" y="33062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3040200" y="32868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3056400" y="326772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3074400" y="32497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3090960" y="3231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3108960" y="32151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>
                <a:off x="3125160" y="3198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3143160" y="31824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>
                <a:off x="3159720" y="31687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3177360" y="31539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3195000" y="31406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3213000" y="31287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3229560" y="31154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3247560" y="31050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>
                <a:off x="3263760" y="3093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3281760" y="30826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3298320" y="30733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3315960" y="30628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3332160" y="30542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3350160" y="30452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>
                <a:off x="3366720" y="303768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3384360" y="30301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3402360" y="30229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3420360" y="30153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>
                <a:off x="3436920" y="3007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3454560" y="30034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>
                <a:off x="3470760" y="29973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>
                <a:off x="3488760" y="29916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>
                <a:off x="3506760" y="29854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"/>
              <p:cNvSpPr/>
              <p:nvPr/>
            </p:nvSpPr>
            <p:spPr>
              <a:xfrm>
                <a:off x="3523320" y="29793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"/>
              <p:cNvSpPr/>
              <p:nvPr/>
            </p:nvSpPr>
            <p:spPr>
              <a:xfrm>
                <a:off x="3541320" y="29750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>
                <a:off x="3557520" y="296928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>
                <a:off x="3575160" y="29664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>
                <a:off x="3591720" y="29617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>
                <a:off x="3611160" y="295704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>
                <a:off x="3627360" y="29541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>
                <a:off x="3645360" y="29498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>
                <a:off x="3661920" y="29466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>
                <a:off x="3679920" y="2942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>
                <a:off x="3696120" y="29390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>
                <a:off x="3713760" y="2936520"/>
                <a:ext cx="1656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>
                <a:off x="3730320" y="293364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>
                <a:off x="3747960" y="29318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>
                <a:off x="3764520" y="29289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>
                <a:off x="3782520" y="29260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>
                <a:off x="3798720" y="29228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>
                <a:off x="3816720" y="29214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>
                <a:off x="3834720" y="29185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>
                <a:off x="3852360" y="29167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>
                <a:off x="3868920" y="29138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>
                <a:off x="3886920" y="29124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>
                <a:off x="3903120" y="2911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>
                <a:off x="3921120" y="29080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>
                <a:off x="3937320" y="29062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>
                <a:off x="3955320" y="29052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>
                <a:off x="3971880" y="290376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>
                <a:off x="3989880" y="29019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>
                <a:off x="4006080" y="2900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>
                <a:off x="4023720" y="28990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>
                <a:off x="4041720" y="2897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>
                <a:off x="4059720" y="28976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>
                <a:off x="4076280" y="28962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>
                <a:off x="4094280" y="28944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>
                <a:off x="4110480" y="28944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>
                <a:off x="4128120" y="28933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>
                <a:off x="4146120" y="289152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>
                <a:off x="4162320" y="28900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>
                <a:off x="4180320" y="28900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4196880" y="28886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4214880" y="28872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>
                <a:off x="4231080" y="28872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4249080" y="288576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>
                <a:off x="4266720" y="28857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>
                <a:off x="4284720" y="28839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>
                <a:off x="4300920" y="28839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>
                <a:off x="4318920" y="28828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>
                <a:off x="4335480" y="28828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>
                <a:off x="4353480" y="288108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>
                <a:off x="4369680" y="28810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>
                <a:off x="4387680" y="28796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>
                <a:off x="4404240" y="2879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>
                <a:off x="4421880" y="28782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>
                <a:off x="4438080" y="28782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>
                <a:off x="4456080" y="28782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>
                <a:off x="4474080" y="2876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4492080" y="2876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4508280" y="2876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4525920" y="28753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>
                <a:off x="4542480" y="2875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4560480" y="28753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4576680" y="2873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4594680" y="28735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4611240" y="2873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4629240" y="28720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4645440" y="2872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4663440" y="28720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>
                <a:off x="4681080" y="2872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4690080" y="2672280"/>
                <a:ext cx="0" cy="240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>
                <a:off x="4673880" y="267228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4673880" y="29124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4176000" y="3002040"/>
                <a:ext cx="0" cy="35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4158000" y="300204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4158000" y="303768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3146040" y="3076560"/>
                <a:ext cx="0" cy="1566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>
                <a:off x="3128040" y="307656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3128040" y="323316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2888280" y="3522600"/>
                <a:ext cx="0" cy="113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5" name=""/>
              <p:cNvSpPr/>
              <p:nvPr/>
            </p:nvSpPr>
            <p:spPr>
              <a:xfrm>
                <a:off x="2870280" y="352260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6" name=""/>
              <p:cNvSpPr/>
              <p:nvPr/>
            </p:nvSpPr>
            <p:spPr>
              <a:xfrm>
                <a:off x="2870280" y="363600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2630160" y="3835800"/>
                <a:ext cx="0" cy="72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2613960" y="38358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>
                <a:off x="2613960" y="390888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2424960" y="3931200"/>
                <a:ext cx="0" cy="727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>
                <a:off x="2406960" y="3931200"/>
                <a:ext cx="356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2406960" y="4004280"/>
                <a:ext cx="356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2372400" y="405216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2116080" y="406080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4673880" y="2775240"/>
                <a:ext cx="3384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4158000" y="300348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3128040" y="313776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2870280" y="3562920"/>
                <a:ext cx="3420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2613960" y="3856680"/>
                <a:ext cx="3384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2406960" y="3950640"/>
                <a:ext cx="3564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2356200" y="403560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2098440" y="404316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3088440" y="4300920"/>
                <a:ext cx="669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 rot="16200000">
                <a:off x="733320" y="3061440"/>
                <a:ext cx="1875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v (pmoles/min) x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5" name=""/>
            <p:cNvSpPr/>
            <p:nvPr/>
          </p:nvSpPr>
          <p:spPr>
            <a:xfrm>
              <a:off x="3139200" y="3429000"/>
              <a:ext cx="1123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= 0.9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6" name=""/>
          <p:cNvGrpSpPr/>
          <p:nvPr/>
        </p:nvGrpSpPr>
        <p:grpSpPr>
          <a:xfrm>
            <a:off x="5270400" y="2203560"/>
            <a:ext cx="3549600" cy="2738160"/>
            <a:chOff x="5270400" y="2203560"/>
            <a:chExt cx="3549600" cy="2738160"/>
          </a:xfrm>
        </p:grpSpPr>
        <p:grpSp>
          <p:nvGrpSpPr>
            <p:cNvPr id="667" name=""/>
            <p:cNvGrpSpPr/>
            <p:nvPr/>
          </p:nvGrpSpPr>
          <p:grpSpPr>
            <a:xfrm>
              <a:off x="5270400" y="2203560"/>
              <a:ext cx="3549600" cy="2738160"/>
              <a:chOff x="5270400" y="2203560"/>
              <a:chExt cx="3549600" cy="2738160"/>
            </a:xfrm>
          </p:grpSpPr>
          <p:sp>
            <p:nvSpPr>
              <p:cNvPr id="668" name=""/>
              <p:cNvSpPr/>
              <p:nvPr/>
            </p:nvSpPr>
            <p:spPr>
              <a:xfrm>
                <a:off x="5270400" y="2203560"/>
                <a:ext cx="3549600" cy="2738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5850360" y="2696400"/>
                <a:ext cx="2572920" cy="1722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6643080" y="2333160"/>
                <a:ext cx="47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NS5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>
                <a:off x="7080840" y="2319480"/>
                <a:ext cx="110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7191000" y="2333160"/>
                <a:ext cx="45648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1 4d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5850360" y="4413600"/>
                <a:ext cx="2574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>
                <a:off x="5850360" y="44136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5782680" y="447948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6708960" y="44136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>
                <a:off x="6568560" y="447948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>
                <a:off x="7566120" y="44136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7388280" y="447948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>
                <a:off x="8424720" y="4413600"/>
                <a:ext cx="0" cy="478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8246880" y="447948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 flipV="1">
                <a:off x="5850360" y="2696040"/>
                <a:ext cx="0" cy="1716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 flipH="1">
                <a:off x="5800680" y="441360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5539320" y="433620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 flipH="1">
                <a:off x="5800680" y="40694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5539320" y="399348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 flipH="1">
                <a:off x="5800680" y="372672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5539320" y="36489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 flipH="1">
                <a:off x="5800680" y="338364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5539320" y="330624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 flipH="1">
                <a:off x="5800680" y="303948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5539320" y="296352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 flipH="1">
                <a:off x="5800680" y="2696400"/>
                <a:ext cx="49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5539320" y="261900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>
                <a:off x="5841360" y="44049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5857920" y="4404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5875560" y="44049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5891760" y="4404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5909760" y="4403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5927760" y="44017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5944320" y="44002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5962320" y="43974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5978520" y="4394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5996520" y="43898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6012720" y="43869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6030360" y="43808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6046920" y="43750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6066360" y="43675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6082920" y="4360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6100920" y="43527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6117120" y="43423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6135120" y="43318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6151680" y="432144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6168960" y="430956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6185520" y="4295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6203520" y="42825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6219720" y="42692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6237720" y="42544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6254280" y="42393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6273720" y="4222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6290280" y="42066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6307920" y="41889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6324120" y="41709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6342120" y="41511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6358680" y="413352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6376320" y="41126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6392880" y="40950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6410880" y="40737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6427080" y="405468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6445080" y="40338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6461640" y="40125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6479280" y="39934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6497280" y="39726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6515280" y="395172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6531480" y="39308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6549480" y="39114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6567480" y="38919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6583680" y="38710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6601320" y="38520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6618240" y="3830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6635880" y="38116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6652080" y="3790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6670080" y="37728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6686640" y="37533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6706080" y="37357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6722640" y="371628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6740280" y="36997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6756840" y="36817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6774480" y="366552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6790680" y="36475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6808680" y="363096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6825240" y="3614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6843240" y="36000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6859440" y="35834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6877440" y="35701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6894000" y="35550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6912000" y="35402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6929280" y="35269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6947280" y="35121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6963840" y="349992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6981840" y="348696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6998040" y="34732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>
                <a:off x="7016040" y="346284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7032600" y="34491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7050600" y="3437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7066800" y="34286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>
                <a:off x="7084440" y="34164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7101000" y="3404520"/>
                <a:ext cx="1728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>
                <a:off x="7118640" y="339408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7136640" y="33854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>
                <a:off x="7154640" y="33750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7171200" y="33656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>
                <a:off x="7189200" y="335700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7205400" y="33483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7223040" y="33390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7241040" y="33303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7257600" y="33228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>
                <a:off x="7275600" y="331524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7291800" y="33062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7309800" y="32986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>
                <a:off x="7326000" y="32914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>
                <a:off x="7345440" y="32853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>
                <a:off x="7361640" y="32778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>
                <a:off x="7379640" y="32720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>
                <a:off x="7396200" y="32648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>
                <a:off x="7414200" y="32587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>
                <a:off x="7430400" y="32511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>
                <a:off x="7448400" y="324684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>
                <a:off x="7464960" y="3240720"/>
                <a:ext cx="1728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>
                <a:off x="7482600" y="323460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>
                <a:off x="7499160" y="32288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>
                <a:off x="7516800" y="3224520"/>
                <a:ext cx="1620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>
                <a:off x="7533360" y="32184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>
                <a:off x="7551000" y="32140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>
                <a:off x="7569000" y="32094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>
                <a:off x="7587000" y="3204720"/>
                <a:ext cx="1656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>
                <a:off x="7603560" y="31993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7621560" y="319428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>
                <a:off x="7637760" y="31899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>
                <a:off x="7655400" y="318564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>
                <a:off x="7671960" y="3181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>
                <a:off x="7689600" y="31780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>
                <a:off x="7706160" y="31752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"/>
              <p:cNvSpPr/>
              <p:nvPr/>
            </p:nvSpPr>
            <p:spPr>
              <a:xfrm>
                <a:off x="7724160" y="31708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>
                <a:off x="7740360" y="316620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>
                <a:off x="7758360" y="316332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>
                <a:off x="7776360" y="315900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>
                <a:off x="7794000" y="31557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>
                <a:off x="7810560" y="3152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>
                <a:off x="7828560" y="31485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>
                <a:off x="7844760" y="31453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>
                <a:off x="7862760" y="314388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>
                <a:off x="7880760" y="314100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>
                <a:off x="7896960" y="313812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>
                <a:off x="7914960" y="313488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>
                <a:off x="7931520" y="313200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>
                <a:off x="7949160" y="312876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>
                <a:off x="7965720" y="31258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>
                <a:off x="7983360" y="312300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>
                <a:off x="8001360" y="3120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>
                <a:off x="8019360" y="311832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>
                <a:off x="8035560" y="31158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8053560" y="311256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>
                <a:off x="8070120" y="31107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>
                <a:off x="8088120" y="31096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>
                <a:off x="8104320" y="310824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>
                <a:off x="8121960" y="31050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>
                <a:off x="8138520" y="310356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>
                <a:off x="8156520" y="3100680"/>
                <a:ext cx="1620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>
                <a:off x="8172720" y="3099240"/>
                <a:ext cx="1764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>
                <a:off x="8190720" y="3097800"/>
                <a:ext cx="1656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>
                <a:off x="8208720" y="3094560"/>
                <a:ext cx="17640" cy="1620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920" bIns="-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>
                <a:off x="8226720" y="3093120"/>
                <a:ext cx="16200" cy="1656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>
                <a:off x="8242920" y="309168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>
                <a:off x="8260560" y="30902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>
                <a:off x="8277120" y="308736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>
                <a:off x="8295120" y="308556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>
                <a:off x="8311320" y="308412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>
                <a:off x="8329320" y="308304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>
                <a:off x="8345880" y="308124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>
                <a:off x="8363880" y="3079800"/>
                <a:ext cx="1620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>
                <a:off x="8380080" y="3078000"/>
                <a:ext cx="1764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>
                <a:off x="8398080" y="3076920"/>
                <a:ext cx="16560" cy="1764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>
                <a:off x="8415720" y="3075480"/>
                <a:ext cx="17640" cy="17280"/>
              </a:xfrm>
              <a:prstGeom prst="ellipse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560" bIns="-34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8424720" y="303516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>
                <a:off x="7910640" y="3045240"/>
                <a:ext cx="0" cy="3128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>
                <a:off x="7892640" y="304524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7892640" y="335844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6880320" y="3555000"/>
                <a:ext cx="0" cy="640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6862320" y="355500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6862320" y="3619440"/>
                <a:ext cx="3384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>
                <a:off x="6622560" y="3707280"/>
                <a:ext cx="0" cy="1965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6604560" y="370728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6604560" y="3903840"/>
                <a:ext cx="34200" cy="360"/>
              </a:xfrm>
              <a:custGeom>
                <a:avLst/>
                <a:gdLst/>
                <a:ahLst/>
                <a:rect l="l" t="t" r="r" b="b"/>
                <a:pathLst>
                  <a:path w="24" h="0">
                    <a:moveTo>
                      <a:pt x="0" y="0"/>
                    </a:moveTo>
                    <a:lnTo>
                      <a:pt x="24" y="0"/>
                    </a:lnTo>
                    <a:lnTo>
                      <a:pt x="0" y="0"/>
                    </a:lnTo>
                  </a:path>
                </a:pathLst>
              </a:custGeom>
              <a:noFill/>
              <a:ln w="190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>
                <a:off x="6364440" y="416052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>
                <a:off x="6158880" y="433620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>
                <a:off x="5850360" y="4413600"/>
                <a:ext cx="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8408520" y="301716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>
                <a:off x="7892640" y="3183840"/>
                <a:ext cx="3420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>
                <a:off x="6862320" y="357156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6604560" y="3787560"/>
                <a:ext cx="34200" cy="3420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600" bIns="-12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6348240" y="414252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6141240" y="4318200"/>
                <a:ext cx="35640" cy="356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160" bIns="-11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5832360" y="4395960"/>
                <a:ext cx="33840" cy="33840"/>
              </a:xfrm>
              <a:prstGeom prst="rect">
                <a:avLst/>
              </a:prstGeom>
              <a:solidFill>
                <a:srgbClr val="000000"/>
              </a:solidFill>
              <a:ln w="1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>
                <a:off x="6823440" y="4653720"/>
                <a:ext cx="669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 rot="16200000">
                <a:off x="4480560" y="3399120"/>
                <a:ext cx="1875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v (pmoles/min) xnM NS5B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7" name=""/>
            <p:cNvSpPr/>
            <p:nvPr/>
          </p:nvSpPr>
          <p:spPr>
            <a:xfrm>
              <a:off x="6955560" y="3789360"/>
              <a:ext cx="1123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= 0.9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8" name=""/>
          <p:cNvGrpSpPr/>
          <p:nvPr/>
        </p:nvGrpSpPr>
        <p:grpSpPr>
          <a:xfrm>
            <a:off x="1476360" y="4448160"/>
            <a:ext cx="3489480" cy="2365560"/>
            <a:chOff x="1476360" y="4448160"/>
            <a:chExt cx="3489480" cy="2365560"/>
          </a:xfrm>
        </p:grpSpPr>
        <p:sp>
          <p:nvSpPr>
            <p:cNvPr id="869" name=""/>
            <p:cNvSpPr/>
            <p:nvPr/>
          </p:nvSpPr>
          <p:spPr>
            <a:xfrm>
              <a:off x="3087720" y="6630840"/>
              <a:ext cx="669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M NS5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3571200" y="5950080"/>
              <a:ext cx="1123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R</a:t>
              </a:r>
              <a:r>
                <a:rPr b="0" lang="en-US" sz="18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= 0.9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71" name=""/>
            <p:cNvGrpSpPr/>
            <p:nvPr/>
          </p:nvGrpSpPr>
          <p:grpSpPr>
            <a:xfrm>
              <a:off x="1476360" y="4448160"/>
              <a:ext cx="3489480" cy="2149200"/>
              <a:chOff x="1476360" y="4448160"/>
              <a:chExt cx="3489480" cy="2149200"/>
            </a:xfrm>
          </p:grpSpPr>
          <p:sp>
            <p:nvSpPr>
              <p:cNvPr id="872" name=""/>
              <p:cNvSpPr/>
              <p:nvPr/>
            </p:nvSpPr>
            <p:spPr>
              <a:xfrm>
                <a:off x="2106360" y="4530600"/>
                <a:ext cx="2735280" cy="1835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>
                <a:off x="2876400" y="4543560"/>
                <a:ext cx="4748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NS5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>
                <a:off x="3341160" y="4529160"/>
                <a:ext cx="110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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>
                <a:off x="3458520" y="4543560"/>
                <a:ext cx="4471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</a:rPr>
                  <a:t>21 5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>
                <a:off x="2106360" y="6359400"/>
                <a:ext cx="2737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>
                <a:off x="2106360" y="6359400"/>
                <a:ext cx="0" cy="51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>
                <a:off x="2034720" y="642960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>
                <a:off x="3017880" y="6359400"/>
                <a:ext cx="0" cy="51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"/>
              <p:cNvSpPr/>
              <p:nvPr/>
            </p:nvSpPr>
            <p:spPr>
              <a:xfrm>
                <a:off x="2868120" y="642960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"/>
              <p:cNvSpPr/>
              <p:nvPr/>
            </p:nvSpPr>
            <p:spPr>
              <a:xfrm>
                <a:off x="3930480" y="6359400"/>
                <a:ext cx="0" cy="51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>
                <a:off x="3741480" y="642960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>
                <a:off x="4843440" y="6359400"/>
                <a:ext cx="0" cy="51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>
                <a:off x="4654080" y="642960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5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 flipV="1">
                <a:off x="2106360" y="4530600"/>
                <a:ext cx="0" cy="182880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 flipH="1">
                <a:off x="2053800" y="6359400"/>
                <a:ext cx="52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>
                <a:off x="1770480" y="62769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 flipH="1">
                <a:off x="2053800" y="5902200"/>
                <a:ext cx="52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>
                <a:off x="1770480" y="58197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 flipH="1">
                <a:off x="2053800" y="5445000"/>
                <a:ext cx="52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>
                <a:off x="1770480" y="53625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 flipH="1">
                <a:off x="2053800" y="4987800"/>
                <a:ext cx="52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>
                <a:off x="1770480" y="49053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 flipH="1">
                <a:off x="2053800" y="4530600"/>
                <a:ext cx="522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>
                <a:off x="1770480" y="44481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2.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>
                <a:off x="4843440" y="4973760"/>
                <a:ext cx="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>
                <a:off x="3930480" y="5491080"/>
                <a:ext cx="0" cy="247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>
                <a:off x="3894120" y="5491080"/>
                <a:ext cx="73080" cy="360"/>
              </a:xfrm>
              <a:custGeom>
                <a:avLst/>
                <a:gdLst/>
                <a:ahLst/>
                <a:rect l="l" t="t" r="r" b="b"/>
                <a:pathLst>
                  <a:path w="48" h="0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3894120" y="5738760"/>
                <a:ext cx="73080" cy="360"/>
              </a:xfrm>
              <a:custGeom>
                <a:avLst/>
                <a:gdLst/>
                <a:ahLst/>
                <a:rect l="l" t="t" r="r" b="b"/>
                <a:pathLst>
                  <a:path w="48" h="0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>
                <a:off x="3017880" y="6072120"/>
                <a:ext cx="0" cy="101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2981160" y="6072120"/>
                <a:ext cx="73080" cy="360"/>
              </a:xfrm>
              <a:custGeom>
                <a:avLst/>
                <a:gdLst/>
                <a:ahLst/>
                <a:rect l="l" t="t" r="r" b="b"/>
                <a:pathLst>
                  <a:path w="48" h="0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2981160" y="6174000"/>
                <a:ext cx="73080" cy="360"/>
              </a:xfrm>
              <a:custGeom>
                <a:avLst/>
                <a:gdLst/>
                <a:ahLst/>
                <a:rect l="l" t="t" r="r" b="b"/>
                <a:pathLst>
                  <a:path w="48" h="0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270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2562120" y="6243840"/>
                <a:ext cx="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2333520" y="6321600"/>
                <a:ext cx="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2106360" y="6359400"/>
                <a:ext cx="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4797360" y="4929120"/>
                <a:ext cx="90360" cy="90720"/>
              </a:xfrm>
              <a:custGeom>
                <a:avLst/>
                <a:gdLst/>
                <a:ahLst/>
                <a:rect l="l" t="t" r="r" b="b"/>
                <a:pathLst>
                  <a:path w="57" h="57">
                    <a:moveTo>
                      <a:pt x="0" y="28"/>
                    </a:moveTo>
                    <a:lnTo>
                      <a:pt x="29" y="57"/>
                    </a:lnTo>
                    <a:lnTo>
                      <a:pt x="57" y="28"/>
                    </a:lnTo>
                    <a:lnTo>
                      <a:pt x="29" y="0"/>
                    </a:lnTo>
                    <a:lnTo>
                      <a:pt x="0" y="28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920" bIns="43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3884400" y="5570640"/>
                <a:ext cx="92160" cy="90360"/>
              </a:xfrm>
              <a:custGeom>
                <a:avLst/>
                <a:gdLst/>
                <a:ahLst/>
                <a:rect l="l" t="t" r="r" b="b"/>
                <a:pathLst>
                  <a:path w="58" h="57">
                    <a:moveTo>
                      <a:pt x="0" y="28"/>
                    </a:moveTo>
                    <a:lnTo>
                      <a:pt x="29" y="57"/>
                    </a:lnTo>
                    <a:lnTo>
                      <a:pt x="58" y="28"/>
                    </a:lnTo>
                    <a:lnTo>
                      <a:pt x="29" y="0"/>
                    </a:lnTo>
                    <a:lnTo>
                      <a:pt x="0" y="28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2973240" y="6077160"/>
                <a:ext cx="90360" cy="91800"/>
              </a:xfrm>
              <a:custGeom>
                <a:avLst/>
                <a:gdLst/>
                <a:ahLst/>
                <a:rect l="l" t="t" r="r" b="b"/>
                <a:pathLst>
                  <a:path w="57" h="58">
                    <a:moveTo>
                      <a:pt x="0" y="29"/>
                    </a:moveTo>
                    <a:lnTo>
                      <a:pt x="28" y="58"/>
                    </a:lnTo>
                    <a:lnTo>
                      <a:pt x="57" y="29"/>
                    </a:lnTo>
                    <a:lnTo>
                      <a:pt x="28" y="0"/>
                    </a:lnTo>
                    <a:lnTo>
                      <a:pt x="0" y="29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2516040" y="6197760"/>
                <a:ext cx="92160" cy="91800"/>
              </a:xfrm>
              <a:custGeom>
                <a:avLst/>
                <a:gdLst/>
                <a:ahLst/>
                <a:rect l="l" t="t" r="r" b="b"/>
                <a:pathLst>
                  <a:path w="58" h="58">
                    <a:moveTo>
                      <a:pt x="0" y="29"/>
                    </a:moveTo>
                    <a:lnTo>
                      <a:pt x="29" y="58"/>
                    </a:lnTo>
                    <a:lnTo>
                      <a:pt x="58" y="29"/>
                    </a:lnTo>
                    <a:lnTo>
                      <a:pt x="29" y="0"/>
                    </a:lnTo>
                    <a:lnTo>
                      <a:pt x="0" y="29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2288880" y="6275520"/>
                <a:ext cx="90720" cy="92160"/>
              </a:xfrm>
              <a:custGeom>
                <a:avLst/>
                <a:gdLst/>
                <a:ahLst/>
                <a:rect l="l" t="t" r="r" b="b"/>
                <a:pathLst>
                  <a:path w="57" h="58">
                    <a:moveTo>
                      <a:pt x="0" y="29"/>
                    </a:moveTo>
                    <a:lnTo>
                      <a:pt x="28" y="58"/>
                    </a:lnTo>
                    <a:lnTo>
                      <a:pt x="57" y="29"/>
                    </a:lnTo>
                    <a:lnTo>
                      <a:pt x="28" y="0"/>
                    </a:lnTo>
                    <a:lnTo>
                      <a:pt x="0" y="29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360" bIns="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2060280" y="6313680"/>
                <a:ext cx="92160" cy="91800"/>
              </a:xfrm>
              <a:custGeom>
                <a:avLst/>
                <a:gdLst/>
                <a:ahLst/>
                <a:rect l="l" t="t" r="r" b="b"/>
                <a:pathLst>
                  <a:path w="58" h="58">
                    <a:moveTo>
                      <a:pt x="0" y="29"/>
                    </a:moveTo>
                    <a:lnTo>
                      <a:pt x="29" y="58"/>
                    </a:lnTo>
                    <a:lnTo>
                      <a:pt x="58" y="29"/>
                    </a:lnTo>
                    <a:lnTo>
                      <a:pt x="29" y="0"/>
                    </a:lnTo>
                    <a:lnTo>
                      <a:pt x="0" y="29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 flipV="1">
                <a:off x="2311200" y="63500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 flipV="1">
                <a:off x="2325600" y="634212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 flipV="1">
                <a:off x="2338200" y="63356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 flipV="1">
                <a:off x="2352600" y="632916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 flipV="1">
                <a:off x="2367000" y="63216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 flipV="1">
                <a:off x="2379600" y="63151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 flipV="1">
                <a:off x="2394000" y="63072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 flipV="1">
                <a:off x="2406600" y="63007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 flipV="1">
                <a:off x="2421000" y="629424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 flipV="1">
                <a:off x="2435040" y="628812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 flipV="1">
                <a:off x="2447640" y="628020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 flipV="1">
                <a:off x="2462040" y="62737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 flipV="1">
                <a:off x="2476440" y="62658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 flipV="1">
                <a:off x="2489040" y="625788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 flipV="1">
                <a:off x="2503440" y="6252840"/>
                <a:ext cx="126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 flipV="1">
                <a:off x="2516040" y="624528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 flipV="1">
                <a:off x="2530440" y="623880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 flipV="1">
                <a:off x="2544480" y="623088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 flipV="1">
                <a:off x="2557440" y="622440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 flipV="1">
                <a:off x="2571480" y="6218280"/>
                <a:ext cx="1296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 flipV="1">
                <a:off x="2584440" y="621036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 flipV="1">
                <a:off x="2598480" y="620388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 flipV="1">
                <a:off x="2612880" y="619596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 flipV="1">
                <a:off x="2625480" y="618948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 flipV="1">
                <a:off x="2639880" y="61819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 flipV="1">
                <a:off x="2654280" y="6176880"/>
                <a:ext cx="12600" cy="5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 flipV="1">
                <a:off x="2666880" y="61689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 flipV="1">
                <a:off x="2681280" y="616248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 flipV="1">
                <a:off x="2693880" y="61549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 flipV="1">
                <a:off x="2708280" y="614700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 flipV="1">
                <a:off x="2722320" y="6141960"/>
                <a:ext cx="12960" cy="5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 flipV="1">
                <a:off x="2735280" y="613404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 flipV="1">
                <a:off x="2749320" y="612756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 flipV="1">
                <a:off x="2763720" y="61200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 flipV="1">
                <a:off x="2776320" y="61135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 flipV="1">
                <a:off x="2790720" y="61056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 flipV="1">
                <a:off x="2817720" y="609264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 flipV="1">
                <a:off x="2832120" y="60850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 flipV="1">
                <a:off x="2844720" y="60786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 flipV="1">
                <a:off x="2859120" y="607068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 flipV="1">
                <a:off x="2873160" y="6065640"/>
                <a:ext cx="1296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 flipV="1">
                <a:off x="2886120" y="605808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 flipV="1">
                <a:off x="2900160" y="6051600"/>
                <a:ext cx="1296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 flipV="1">
                <a:off x="2913120" y="604368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 flipV="1">
                <a:off x="2927160" y="60357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 flipV="1">
                <a:off x="2941560" y="6030720"/>
                <a:ext cx="126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 flipV="1">
                <a:off x="2954160" y="60231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 flipV="1">
                <a:off x="2968560" y="601668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 flipV="1">
                <a:off x="2981160" y="60087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 flipV="1">
                <a:off x="2995560" y="600228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 flipV="1">
                <a:off x="3009960" y="599436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 flipV="1">
                <a:off x="3022560" y="598788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 flipV="1">
                <a:off x="3036600" y="598176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 flipV="1">
                <a:off x="3051000" y="597384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 flipV="1">
                <a:off x="3063600" y="596736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 flipV="1">
                <a:off x="3078000" y="595944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 flipV="1">
                <a:off x="3090600" y="5954400"/>
                <a:ext cx="144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 flipV="1">
                <a:off x="3105000" y="59468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 flipV="1">
                <a:off x="3119400" y="594036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 flipV="1">
                <a:off x="3132000" y="59324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 flipV="1">
                <a:off x="3146400" y="592452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 flipV="1">
                <a:off x="3160440" y="5918040"/>
                <a:ext cx="1296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 flipV="1">
                <a:off x="3173400" y="591192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 flipV="1">
                <a:off x="3187440" y="5905440"/>
                <a:ext cx="1296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 flipV="1">
                <a:off x="3200400" y="589752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 flipV="1">
                <a:off x="3214440" y="589104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 flipV="1">
                <a:off x="3228840" y="58834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 flipV="1">
                <a:off x="3241440" y="58770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 flipV="1">
                <a:off x="3255840" y="587052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 flipV="1">
                <a:off x="3268440" y="586260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 flipV="1">
                <a:off x="3282840" y="585612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 flipV="1">
                <a:off x="3297240" y="584856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 flipV="1">
                <a:off x="3309840" y="584208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 flipV="1">
                <a:off x="3324240" y="583560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 flipV="1">
                <a:off x="3338280" y="5829120"/>
                <a:ext cx="1296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 flipV="1">
                <a:off x="3351240" y="582156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 flipV="1">
                <a:off x="3365280" y="581364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 flipV="1">
                <a:off x="3378240" y="580716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 flipV="1">
                <a:off x="3392280" y="580068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 flipV="1">
                <a:off x="3406680" y="579420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 flipV="1">
                <a:off x="3419280" y="57866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 flipV="1">
                <a:off x="3433680" y="578016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 flipV="1">
                <a:off x="3448080" y="577224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 flipV="1">
                <a:off x="3460680" y="576576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 flipV="1">
                <a:off x="3475080" y="575928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 flipV="1">
                <a:off x="3487680" y="57517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 flipV="1">
                <a:off x="3502080" y="574524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 flipV="1">
                <a:off x="3516120" y="573732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 flipV="1">
                <a:off x="3528720" y="57308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 flipV="1">
                <a:off x="3543120" y="572436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 flipV="1">
                <a:off x="3555720" y="57182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 flipV="1">
                <a:off x="3570120" y="57103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 flipV="1">
                <a:off x="3584520" y="57024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 flipV="1">
                <a:off x="3597120" y="56959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 flipV="1">
                <a:off x="3611520" y="568944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 flipV="1">
                <a:off x="3625560" y="5683320"/>
                <a:ext cx="1296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 flipV="1">
                <a:off x="3638520" y="567540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 flipV="1">
                <a:off x="3652560" y="5668920"/>
                <a:ext cx="1296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 flipV="1">
                <a:off x="3665520" y="566100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 flipV="1">
                <a:off x="3679560" y="565308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 flipV="1">
                <a:off x="3693960" y="5648040"/>
                <a:ext cx="126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 flipV="1">
                <a:off x="3706560" y="564048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 flipV="1">
                <a:off x="3720960" y="56340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 flipV="1">
                <a:off x="3735360" y="56260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 flipV="1">
                <a:off x="3747960" y="561960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 flipV="1">
                <a:off x="3762360" y="561348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 flipV="1">
                <a:off x="3774960" y="56070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 flipV="1">
                <a:off x="3789360" y="559908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 flipV="1">
                <a:off x="3803400" y="559116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 flipV="1">
                <a:off x="3816360" y="558468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 flipV="1">
                <a:off x="3830400" y="55771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 flipV="1">
                <a:off x="3844800" y="5572080"/>
                <a:ext cx="12600" cy="504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760" bIns="-41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 flipV="1">
                <a:off x="3857400" y="55641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 flipV="1">
                <a:off x="3871800" y="555768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 flipV="1">
                <a:off x="3884400" y="55501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 flipV="1">
                <a:off x="3898800" y="5541480"/>
                <a:ext cx="1440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 flipV="1">
                <a:off x="3913200" y="5536800"/>
                <a:ext cx="126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 flipV="1">
                <a:off x="3925800" y="55292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 flipV="1">
                <a:off x="3940200" y="552276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 flipV="1">
                <a:off x="3952800" y="551520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 flipV="1">
                <a:off x="3967200" y="550872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 flipV="1">
                <a:off x="3981240" y="550080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 flipV="1">
                <a:off x="3994200" y="5495760"/>
                <a:ext cx="1404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 flipV="1">
                <a:off x="4022640" y="54802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 flipV="1">
                <a:off x="4035240" y="54738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 flipV="1">
                <a:off x="4049640" y="54658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 flipV="1">
                <a:off x="4062240" y="5460840"/>
                <a:ext cx="144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 flipV="1">
                <a:off x="4076640" y="545328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 flipV="1">
                <a:off x="4091040" y="544680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 flipV="1">
                <a:off x="4103640" y="543888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 flipV="1">
                <a:off x="4117680" y="54309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 flipV="1">
                <a:off x="4132080" y="542448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 flipV="1">
                <a:off x="4144680" y="541800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 flipV="1">
                <a:off x="4159080" y="541188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 flipV="1">
                <a:off x="4171680" y="540396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7" name=""/>
              <p:cNvSpPr/>
              <p:nvPr/>
            </p:nvSpPr>
            <p:spPr>
              <a:xfrm flipV="1">
                <a:off x="4186080" y="539748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8" name=""/>
              <p:cNvSpPr/>
              <p:nvPr/>
            </p:nvSpPr>
            <p:spPr>
              <a:xfrm flipV="1">
                <a:off x="4200480" y="538956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9" name=""/>
              <p:cNvSpPr/>
              <p:nvPr/>
            </p:nvSpPr>
            <p:spPr>
              <a:xfrm flipV="1">
                <a:off x="4213080" y="5384520"/>
                <a:ext cx="144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0" name=""/>
              <p:cNvSpPr/>
              <p:nvPr/>
            </p:nvSpPr>
            <p:spPr>
              <a:xfrm flipV="1">
                <a:off x="4227480" y="537696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1" name=""/>
              <p:cNvSpPr/>
              <p:nvPr/>
            </p:nvSpPr>
            <p:spPr>
              <a:xfrm flipV="1">
                <a:off x="4240080" y="53690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2" name=""/>
              <p:cNvSpPr/>
              <p:nvPr/>
            </p:nvSpPr>
            <p:spPr>
              <a:xfrm flipV="1">
                <a:off x="4254480" y="536256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3" name=""/>
              <p:cNvSpPr/>
              <p:nvPr/>
            </p:nvSpPr>
            <p:spPr>
              <a:xfrm flipV="1">
                <a:off x="4268520" y="535464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4" name=""/>
              <p:cNvSpPr/>
              <p:nvPr/>
            </p:nvSpPr>
            <p:spPr>
              <a:xfrm flipV="1">
                <a:off x="4281480" y="534816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5" name=""/>
              <p:cNvSpPr/>
              <p:nvPr/>
            </p:nvSpPr>
            <p:spPr>
              <a:xfrm flipV="1">
                <a:off x="4295520" y="53420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6" name=""/>
              <p:cNvSpPr/>
              <p:nvPr/>
            </p:nvSpPr>
            <p:spPr>
              <a:xfrm flipV="1">
                <a:off x="4309920" y="533556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7" name=""/>
              <p:cNvSpPr/>
              <p:nvPr/>
            </p:nvSpPr>
            <p:spPr>
              <a:xfrm flipV="1">
                <a:off x="4322520" y="53276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 flipV="1">
                <a:off x="4336920" y="531972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9" name=""/>
              <p:cNvSpPr/>
              <p:nvPr/>
            </p:nvSpPr>
            <p:spPr>
              <a:xfrm flipV="1">
                <a:off x="4349520" y="531324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0" name=""/>
              <p:cNvSpPr/>
              <p:nvPr/>
            </p:nvSpPr>
            <p:spPr>
              <a:xfrm flipV="1">
                <a:off x="4363920" y="530676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1" name=""/>
              <p:cNvSpPr/>
              <p:nvPr/>
            </p:nvSpPr>
            <p:spPr>
              <a:xfrm flipV="1">
                <a:off x="4378320" y="5300640"/>
                <a:ext cx="126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 flipV="1">
                <a:off x="4390920" y="52927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3" name=""/>
              <p:cNvSpPr/>
              <p:nvPr/>
            </p:nvSpPr>
            <p:spPr>
              <a:xfrm flipV="1">
                <a:off x="4405320" y="5286240"/>
                <a:ext cx="1404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4" name=""/>
              <p:cNvSpPr/>
              <p:nvPr/>
            </p:nvSpPr>
            <p:spPr>
              <a:xfrm flipV="1">
                <a:off x="4419360" y="5277960"/>
                <a:ext cx="1296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5" name=""/>
              <p:cNvSpPr/>
              <p:nvPr/>
            </p:nvSpPr>
            <p:spPr>
              <a:xfrm flipV="1">
                <a:off x="4432320" y="5273280"/>
                <a:ext cx="1404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 flipV="1">
                <a:off x="4446360" y="526572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7" name=""/>
              <p:cNvSpPr/>
              <p:nvPr/>
            </p:nvSpPr>
            <p:spPr>
              <a:xfrm flipV="1">
                <a:off x="4459320" y="5257800"/>
                <a:ext cx="1404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8" name=""/>
              <p:cNvSpPr/>
              <p:nvPr/>
            </p:nvSpPr>
            <p:spPr>
              <a:xfrm flipV="1">
                <a:off x="4473360" y="525132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9" name=""/>
              <p:cNvSpPr/>
              <p:nvPr/>
            </p:nvSpPr>
            <p:spPr>
              <a:xfrm flipV="1">
                <a:off x="4487760" y="5243040"/>
                <a:ext cx="1260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0" name=""/>
              <p:cNvSpPr/>
              <p:nvPr/>
            </p:nvSpPr>
            <p:spPr>
              <a:xfrm flipV="1">
                <a:off x="4500360" y="523692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 flipV="1">
                <a:off x="4514760" y="523080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2" name=""/>
              <p:cNvSpPr/>
              <p:nvPr/>
            </p:nvSpPr>
            <p:spPr>
              <a:xfrm flipV="1">
                <a:off x="4529160" y="522432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3" name=""/>
              <p:cNvSpPr/>
              <p:nvPr/>
            </p:nvSpPr>
            <p:spPr>
              <a:xfrm flipV="1">
                <a:off x="4541760" y="5216040"/>
                <a:ext cx="1440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4" name=""/>
              <p:cNvSpPr/>
              <p:nvPr/>
            </p:nvSpPr>
            <p:spPr>
              <a:xfrm flipV="1">
                <a:off x="4556160" y="520848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 flipV="1">
                <a:off x="4568760" y="520200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6" name=""/>
              <p:cNvSpPr/>
              <p:nvPr/>
            </p:nvSpPr>
            <p:spPr>
              <a:xfrm flipV="1">
                <a:off x="4583160" y="519588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7" name=""/>
              <p:cNvSpPr/>
              <p:nvPr/>
            </p:nvSpPr>
            <p:spPr>
              <a:xfrm flipV="1">
                <a:off x="4597200" y="5189400"/>
                <a:ext cx="1296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8" name=""/>
              <p:cNvSpPr/>
              <p:nvPr/>
            </p:nvSpPr>
            <p:spPr>
              <a:xfrm flipV="1">
                <a:off x="4610160" y="5181120"/>
                <a:ext cx="1404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 flipV="1">
                <a:off x="4624200" y="517500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0" name=""/>
              <p:cNvSpPr/>
              <p:nvPr/>
            </p:nvSpPr>
            <p:spPr>
              <a:xfrm flipV="1">
                <a:off x="4636800" y="516744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1" name=""/>
              <p:cNvSpPr/>
              <p:nvPr/>
            </p:nvSpPr>
            <p:spPr>
              <a:xfrm flipV="1">
                <a:off x="4651200" y="516096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2" name=""/>
              <p:cNvSpPr/>
              <p:nvPr/>
            </p:nvSpPr>
            <p:spPr>
              <a:xfrm flipV="1">
                <a:off x="4665600" y="5154480"/>
                <a:ext cx="126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 flipV="1">
                <a:off x="4678200" y="5146200"/>
                <a:ext cx="14400" cy="82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4" name=""/>
              <p:cNvSpPr/>
              <p:nvPr/>
            </p:nvSpPr>
            <p:spPr>
              <a:xfrm flipV="1">
                <a:off x="4692600" y="5140080"/>
                <a:ext cx="1440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5" name=""/>
              <p:cNvSpPr/>
              <p:nvPr/>
            </p:nvSpPr>
            <p:spPr>
              <a:xfrm flipV="1">
                <a:off x="4707000" y="513252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6" name=""/>
              <p:cNvSpPr/>
              <p:nvPr/>
            </p:nvSpPr>
            <p:spPr>
              <a:xfrm flipV="1">
                <a:off x="4719600" y="512604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7" name=""/>
              <p:cNvSpPr/>
              <p:nvPr/>
            </p:nvSpPr>
            <p:spPr>
              <a:xfrm flipV="1">
                <a:off x="4733640" y="5119560"/>
                <a:ext cx="12960" cy="61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680" bIns="-40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 flipV="1">
                <a:off x="4746600" y="5113440"/>
                <a:ext cx="1404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9" name=""/>
              <p:cNvSpPr/>
              <p:nvPr/>
            </p:nvSpPr>
            <p:spPr>
              <a:xfrm flipV="1">
                <a:off x="4760640" y="510552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0" name=""/>
              <p:cNvSpPr/>
              <p:nvPr/>
            </p:nvSpPr>
            <p:spPr>
              <a:xfrm flipV="1">
                <a:off x="4775040" y="5097600"/>
                <a:ext cx="126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1" name=""/>
              <p:cNvSpPr/>
              <p:nvPr/>
            </p:nvSpPr>
            <p:spPr>
              <a:xfrm flipV="1">
                <a:off x="4787640" y="5091120"/>
                <a:ext cx="14400" cy="64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 flipV="1">
                <a:off x="4802040" y="508320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3" name=""/>
              <p:cNvSpPr/>
              <p:nvPr/>
            </p:nvSpPr>
            <p:spPr>
              <a:xfrm flipV="1">
                <a:off x="4816440" y="5078160"/>
                <a:ext cx="12600" cy="468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4" name=""/>
              <p:cNvSpPr/>
              <p:nvPr/>
            </p:nvSpPr>
            <p:spPr>
              <a:xfrm flipV="1">
                <a:off x="4829040" y="5070600"/>
                <a:ext cx="1440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 rot="16200000">
                <a:off x="698040" y="5349240"/>
                <a:ext cx="17244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v (pmoles/min) xnM NS5B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 flipV="1">
                <a:off x="2803320" y="6097680"/>
                <a:ext cx="12960" cy="792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18T10:03:05Z</dcterms:created>
  <dc:creator>Antonio Mas</dc:creator>
  <dc:description/>
  <dc:language>en-US</dc:language>
  <cp:lastModifiedBy>Antonio Mas</cp:lastModifiedBy>
  <dcterms:modified xsi:type="dcterms:W3CDTF">2011-02-28T16:49:31Z</dcterms:modified>
  <cp:revision>4</cp:revision>
  <dc:subject/>
  <dc:title>Diapositiva 1</dc:title>
</cp:coreProperties>
</file>